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9.jpeg" ContentType="image/jpeg"/>
  <Override PartName="/ppt/media/image11.jpeg" ContentType="image/jpeg"/>
  <Override PartName="/ppt/media/image16.png" ContentType="image/png"/>
  <Override PartName="/ppt/media/image14.png" ContentType="image/png"/>
  <Override PartName="/ppt/media/image1.jpeg" ContentType="image/jpeg"/>
  <Override PartName="/ppt/media/image2.jpeg" ContentType="image/jpeg"/>
  <Override PartName="/ppt/media/image5.jpeg" ContentType="image/jpeg"/>
  <Override PartName="/ppt/media/image10.jpeg" ContentType="image/jpeg"/>
  <Override PartName="/ppt/media/image15.png" ContentType="image/png"/>
  <Override PartName="/ppt/media/image3.jpeg" ContentType="image/jpeg"/>
  <Override PartName="/ppt/media/image4.jpeg" ContentType="image/jpeg"/>
  <Override PartName="/ppt/media/image6.jpeg" ContentType="image/jpeg"/>
  <Override PartName="/ppt/media/image8.png" ContentType="image/png"/>
  <Override PartName="/ppt/media/image7.jpeg" ContentType="image/jpeg"/>
  <Override PartName="/ppt/media/image12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68834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83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8116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98800" y="0"/>
            <a:ext cx="298152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33720" y="696960"/>
            <a:ext cx="261432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5000" bIns="450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7240" y="4414680"/>
            <a:ext cx="5507280" cy="418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29720"/>
            <a:ext cx="298116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98800" y="8829720"/>
            <a:ext cx="298152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C30EF3-7895-41F2-A678-CDF6D8DE708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sldImg"/>
          </p:nvPr>
        </p:nvSpPr>
        <p:spPr>
          <a:xfrm>
            <a:off x="2133720" y="696960"/>
            <a:ext cx="2614320" cy="3486240"/>
          </a:xfrm>
          <a:prstGeom prst="rect">
            <a:avLst/>
          </a:prstGeom>
          <a:ln w="0">
            <a:noFill/>
          </a:ln>
        </p:spPr>
      </p:sp>
      <p:sp>
        <p:nvSpPr>
          <p:cNvPr id="100" name="PlaceHolder 2"/>
          <p:cNvSpPr>
            <a:spLocks noGrp="1"/>
          </p:cNvSpPr>
          <p:nvPr>
            <p:ph type="body"/>
          </p:nvPr>
        </p:nvSpPr>
        <p:spPr>
          <a:xfrm>
            <a:off x="687240" y="4414680"/>
            <a:ext cx="5507280" cy="418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Slide Number Placeholder 3"/>
          <p:cNvSpPr/>
          <p:nvPr/>
        </p:nvSpPr>
        <p:spPr>
          <a:xfrm>
            <a:off x="3898800" y="8829720"/>
            <a:ext cx="298152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A2CF1F-BF72-4E4E-BAC9-C57B00FC56A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72625D-022C-416C-9628-20763BA4D9C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A170A0-8CCB-4A50-B92D-03893672DE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846B6-A363-47CF-AF84-11AACB7CF3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7864A-97D8-4774-99AE-9098FE0705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14BB12-E298-493F-9780-DD39C6A2A7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8DBC9-4843-48B5-86E5-1955668A83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7C21B-A5CE-4F3D-966E-5BEFAC9C78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6C7FF-C856-4685-B069-56E902EDF6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1336F-3F15-423C-9B48-9AD08D513B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4AD51-59A8-4F5A-8BAC-C32E680C83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75176-18E7-4EDC-A8DE-33C6C070FE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811C5-2C01-4066-AF47-9E298E6753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D00B4E-8FC4-479A-8CCF-E551B9F26C4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5" Type="http://schemas.openxmlformats.org/officeDocument/2006/relationships/image" Target="../media/image13.jpe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1057320" y="393840"/>
            <a:ext cx="2828880" cy="21207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" descr=""/>
          <p:cNvPicPr/>
          <p:nvPr/>
        </p:nvPicPr>
        <p:blipFill>
          <a:blip r:embed="rId2"/>
          <a:stretch/>
        </p:blipFill>
        <p:spPr>
          <a:xfrm>
            <a:off x="3952800" y="393840"/>
            <a:ext cx="2828880" cy="21207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6" descr=""/>
          <p:cNvPicPr/>
          <p:nvPr/>
        </p:nvPicPr>
        <p:blipFill>
          <a:blip r:embed="rId3"/>
          <a:stretch/>
        </p:blipFill>
        <p:spPr>
          <a:xfrm>
            <a:off x="1057320" y="2603520"/>
            <a:ext cx="2828880" cy="21207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7" descr=""/>
          <p:cNvPicPr/>
          <p:nvPr/>
        </p:nvPicPr>
        <p:blipFill>
          <a:blip r:embed="rId4"/>
          <a:stretch/>
        </p:blipFill>
        <p:spPr>
          <a:xfrm>
            <a:off x="1057320" y="4813200"/>
            <a:ext cx="2828880" cy="21211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8" descr=""/>
          <p:cNvPicPr/>
          <p:nvPr/>
        </p:nvPicPr>
        <p:blipFill>
          <a:blip r:embed="rId5"/>
          <a:stretch/>
        </p:blipFill>
        <p:spPr>
          <a:xfrm>
            <a:off x="3962520" y="4813200"/>
            <a:ext cx="2828880" cy="212112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9" descr=""/>
          <p:cNvPicPr/>
          <p:nvPr/>
        </p:nvPicPr>
        <p:blipFill>
          <a:blip r:embed="rId6"/>
          <a:stretch/>
        </p:blipFill>
        <p:spPr>
          <a:xfrm>
            <a:off x="1057320" y="7010280"/>
            <a:ext cx="2828880" cy="212112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0" descr=""/>
          <p:cNvPicPr/>
          <p:nvPr/>
        </p:nvPicPr>
        <p:blipFill>
          <a:blip r:embed="rId7"/>
          <a:stretch/>
        </p:blipFill>
        <p:spPr>
          <a:xfrm>
            <a:off x="3962520" y="7010280"/>
            <a:ext cx="2828880" cy="2121120"/>
          </a:xfrm>
          <a:prstGeom prst="rect">
            <a:avLst/>
          </a:prstGeom>
          <a:ln w="0">
            <a:noFill/>
          </a:ln>
        </p:spPr>
      </p:pic>
      <p:sp>
        <p:nvSpPr>
          <p:cNvPr id="55" name="TextBox 11"/>
          <p:cNvSpPr/>
          <p:nvPr/>
        </p:nvSpPr>
        <p:spPr>
          <a:xfrm>
            <a:off x="1932120" y="28440"/>
            <a:ext cx="404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 Weeks                                            4 Week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2"/>
          <p:cNvSpPr/>
          <p:nvPr/>
        </p:nvSpPr>
        <p:spPr>
          <a:xfrm>
            <a:off x="135360" y="1130400"/>
            <a:ext cx="918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caffol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lo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3"/>
          <p:cNvSpPr/>
          <p:nvPr/>
        </p:nvSpPr>
        <p:spPr>
          <a:xfrm>
            <a:off x="280080" y="3340080"/>
            <a:ext cx="697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M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lo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4"/>
          <p:cNvSpPr/>
          <p:nvPr/>
        </p:nvSpPr>
        <p:spPr>
          <a:xfrm>
            <a:off x="208440" y="5638680"/>
            <a:ext cx="768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DF-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lo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5"/>
          <p:cNvSpPr/>
          <p:nvPr/>
        </p:nvSpPr>
        <p:spPr>
          <a:xfrm>
            <a:off x="2880" y="7797960"/>
            <a:ext cx="11196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MP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0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 SDF-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3" descr="C:\Users\jinqm\Desktop\E4W1-10X=BMP4w.tif"/>
          <p:cNvPicPr/>
          <p:nvPr/>
        </p:nvPicPr>
        <p:blipFill>
          <a:blip r:embed="rId8"/>
          <a:stretch/>
        </p:blipFill>
        <p:spPr>
          <a:xfrm>
            <a:off x="3962520" y="2590920"/>
            <a:ext cx="2828880" cy="2120760"/>
          </a:xfrm>
          <a:prstGeom prst="rect">
            <a:avLst/>
          </a:prstGeom>
          <a:ln w="0">
            <a:noFill/>
          </a:ln>
        </p:spPr>
      </p:pic>
      <p:sp>
        <p:nvSpPr>
          <p:cNvPr id="61" name="Flowchart: Connector 16"/>
          <p:cNvSpPr/>
          <p:nvPr/>
        </p:nvSpPr>
        <p:spPr>
          <a:xfrm>
            <a:off x="2209680" y="2895480"/>
            <a:ext cx="5724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AutoShape 26"/>
          <p:cNvSpPr/>
          <p:nvPr/>
        </p:nvSpPr>
        <p:spPr>
          <a:xfrm>
            <a:off x="5029200" y="2849400"/>
            <a:ext cx="46080" cy="46080"/>
          </a:xfrm>
          <a:prstGeom prst="diamond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3760" bIns="-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lowchart: Connector 18"/>
          <p:cNvSpPr/>
          <p:nvPr/>
        </p:nvSpPr>
        <p:spPr>
          <a:xfrm>
            <a:off x="4419720" y="3124080"/>
            <a:ext cx="5688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AutoShape 42"/>
          <p:cNvSpPr/>
          <p:nvPr/>
        </p:nvSpPr>
        <p:spPr>
          <a:xfrm>
            <a:off x="1514520" y="8310600"/>
            <a:ext cx="42840" cy="47520"/>
          </a:xfrm>
          <a:custGeom>
            <a:avLst/>
            <a:gdLst/>
            <a:ahLst/>
            <a:rect l="l" t="t" r="r" b="b"/>
            <a:pathLst>
              <a:path w="42863" h="47625">
                <a:moveTo>
                  <a:pt x="0" y="18191"/>
                </a:moveTo>
                <a:lnTo>
                  <a:pt x="16372" y="18191"/>
                </a:lnTo>
                <a:lnTo>
                  <a:pt x="21432" y="0"/>
                </a:lnTo>
                <a:lnTo>
                  <a:pt x="26491" y="18191"/>
                </a:lnTo>
                <a:lnTo>
                  <a:pt x="-22673" y="18191"/>
                </a:lnTo>
                <a:lnTo>
                  <a:pt x="29617" y="29434"/>
                </a:lnTo>
                <a:lnTo>
                  <a:pt x="-30859" y="-17911"/>
                </a:lnTo>
                <a:lnTo>
                  <a:pt x="21432" y="-29154"/>
                </a:lnTo>
                <a:lnTo>
                  <a:pt x="8186" y="-17911"/>
                </a:lnTo>
                <a:lnTo>
                  <a:pt x="13246" y="29434"/>
                </a:lnTo>
                <a:lnTo>
                  <a:pt x="0" y="18191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AutoShape 42"/>
          <p:cNvSpPr/>
          <p:nvPr/>
        </p:nvSpPr>
        <p:spPr>
          <a:xfrm>
            <a:off x="4038480" y="7620120"/>
            <a:ext cx="42840" cy="47520"/>
          </a:xfrm>
          <a:custGeom>
            <a:avLst/>
            <a:gdLst/>
            <a:ahLst/>
            <a:rect l="l" t="t" r="r" b="b"/>
            <a:pathLst>
              <a:path w="42863" h="47625">
                <a:moveTo>
                  <a:pt x="0" y="18191"/>
                </a:moveTo>
                <a:lnTo>
                  <a:pt x="16372" y="18191"/>
                </a:lnTo>
                <a:lnTo>
                  <a:pt x="21432" y="0"/>
                </a:lnTo>
                <a:lnTo>
                  <a:pt x="26491" y="18191"/>
                </a:lnTo>
                <a:lnTo>
                  <a:pt x="-22673" y="18191"/>
                </a:lnTo>
                <a:lnTo>
                  <a:pt x="29617" y="29434"/>
                </a:lnTo>
                <a:lnTo>
                  <a:pt x="-30859" y="-17911"/>
                </a:lnTo>
                <a:lnTo>
                  <a:pt x="21432" y="-29154"/>
                </a:lnTo>
                <a:lnTo>
                  <a:pt x="8186" y="-17911"/>
                </a:lnTo>
                <a:lnTo>
                  <a:pt x="13246" y="29434"/>
                </a:lnTo>
                <a:lnTo>
                  <a:pt x="0" y="18191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lowchart: Connector 21"/>
          <p:cNvSpPr/>
          <p:nvPr/>
        </p:nvSpPr>
        <p:spPr>
          <a:xfrm>
            <a:off x="5486400" y="8534520"/>
            <a:ext cx="57240" cy="4896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lowchart: Connector 23"/>
          <p:cNvSpPr/>
          <p:nvPr/>
        </p:nvSpPr>
        <p:spPr>
          <a:xfrm>
            <a:off x="3352680" y="7238880"/>
            <a:ext cx="5724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1" descr=""/>
          <p:cNvPicPr/>
          <p:nvPr/>
        </p:nvPicPr>
        <p:blipFill>
          <a:blip r:embed="rId1"/>
          <a:stretch/>
        </p:blipFill>
        <p:spPr>
          <a:xfrm>
            <a:off x="1060560" y="393840"/>
            <a:ext cx="2828880" cy="212076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2" descr=""/>
          <p:cNvPicPr/>
          <p:nvPr/>
        </p:nvPicPr>
        <p:blipFill>
          <a:blip r:embed="rId2"/>
          <a:stretch/>
        </p:blipFill>
        <p:spPr>
          <a:xfrm>
            <a:off x="3949560" y="393840"/>
            <a:ext cx="2829240" cy="212076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3" descr=""/>
          <p:cNvPicPr/>
          <p:nvPr/>
        </p:nvPicPr>
        <p:blipFill>
          <a:blip r:embed="rId3"/>
          <a:stretch/>
        </p:blipFill>
        <p:spPr>
          <a:xfrm>
            <a:off x="1060560" y="2606760"/>
            <a:ext cx="2828880" cy="21207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4" descr=""/>
          <p:cNvPicPr/>
          <p:nvPr/>
        </p:nvPicPr>
        <p:blipFill>
          <a:blip r:embed="rId4"/>
          <a:stretch/>
        </p:blipFill>
        <p:spPr>
          <a:xfrm>
            <a:off x="3949560" y="2606760"/>
            <a:ext cx="2829240" cy="212076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5" descr=""/>
          <p:cNvPicPr/>
          <p:nvPr/>
        </p:nvPicPr>
        <p:blipFill>
          <a:blip r:embed="rId5"/>
          <a:stretch/>
        </p:blipFill>
        <p:spPr>
          <a:xfrm>
            <a:off x="1060560" y="4809960"/>
            <a:ext cx="2828880" cy="2121120"/>
          </a:xfrm>
          <a:prstGeom prst="rect">
            <a:avLst/>
          </a:prstGeom>
          <a:ln w="0">
            <a:noFill/>
          </a:ln>
        </p:spPr>
      </p:pic>
      <p:sp>
        <p:nvSpPr>
          <p:cNvPr id="73" name="TextBox 9"/>
          <p:cNvSpPr/>
          <p:nvPr/>
        </p:nvSpPr>
        <p:spPr>
          <a:xfrm>
            <a:off x="1932120" y="28440"/>
            <a:ext cx="404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 Weeks                                            4 Week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0"/>
          <p:cNvSpPr/>
          <p:nvPr/>
        </p:nvSpPr>
        <p:spPr>
          <a:xfrm>
            <a:off x="-23040" y="7797960"/>
            <a:ext cx="11714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MP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0.5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 SDF-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1"/>
          <p:cNvSpPr/>
          <p:nvPr/>
        </p:nvSpPr>
        <p:spPr>
          <a:xfrm>
            <a:off x="-36000" y="5578560"/>
            <a:ext cx="1017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MP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 SDF-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2"/>
          <p:cNvSpPr/>
          <p:nvPr/>
        </p:nvSpPr>
        <p:spPr>
          <a:xfrm>
            <a:off x="-16920" y="3505320"/>
            <a:ext cx="1017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MP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 SDF-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13"/>
          <p:cNvSpPr/>
          <p:nvPr/>
        </p:nvSpPr>
        <p:spPr>
          <a:xfrm>
            <a:off x="-36000" y="1162080"/>
            <a:ext cx="1017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MP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 SDF-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lowchart: Connector 15"/>
          <p:cNvSpPr/>
          <p:nvPr/>
        </p:nvSpPr>
        <p:spPr>
          <a:xfrm>
            <a:off x="4191120" y="7924680"/>
            <a:ext cx="5688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lowchart: Connector 16"/>
          <p:cNvSpPr/>
          <p:nvPr/>
        </p:nvSpPr>
        <p:spPr>
          <a:xfrm>
            <a:off x="2362320" y="1219320"/>
            <a:ext cx="56880" cy="4896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lowchart: Connector 17"/>
          <p:cNvSpPr/>
          <p:nvPr/>
        </p:nvSpPr>
        <p:spPr>
          <a:xfrm>
            <a:off x="5105520" y="1160640"/>
            <a:ext cx="56880" cy="4896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lowchart: Connector 18"/>
          <p:cNvSpPr/>
          <p:nvPr/>
        </p:nvSpPr>
        <p:spPr>
          <a:xfrm>
            <a:off x="2590920" y="4114800"/>
            <a:ext cx="5688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AutoShape 42"/>
          <p:cNvSpPr/>
          <p:nvPr/>
        </p:nvSpPr>
        <p:spPr>
          <a:xfrm>
            <a:off x="1219320" y="3581280"/>
            <a:ext cx="42840" cy="47880"/>
          </a:xfrm>
          <a:custGeom>
            <a:avLst/>
            <a:gdLst/>
            <a:ahLst/>
            <a:rect l="l" t="t" r="r" b="b"/>
            <a:pathLst>
              <a:path w="42863" h="47625">
                <a:moveTo>
                  <a:pt x="0" y="18191"/>
                </a:moveTo>
                <a:lnTo>
                  <a:pt x="16372" y="18191"/>
                </a:lnTo>
                <a:lnTo>
                  <a:pt x="21432" y="0"/>
                </a:lnTo>
                <a:lnTo>
                  <a:pt x="26491" y="18191"/>
                </a:lnTo>
                <a:lnTo>
                  <a:pt x="-22673" y="18191"/>
                </a:lnTo>
                <a:lnTo>
                  <a:pt x="29617" y="29434"/>
                </a:lnTo>
                <a:lnTo>
                  <a:pt x="-30859" y="-17911"/>
                </a:lnTo>
                <a:lnTo>
                  <a:pt x="21432" y="-29154"/>
                </a:lnTo>
                <a:lnTo>
                  <a:pt x="8186" y="-17911"/>
                </a:lnTo>
                <a:lnTo>
                  <a:pt x="13246" y="29434"/>
                </a:lnTo>
                <a:lnTo>
                  <a:pt x="0" y="18191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AutoShape 42"/>
          <p:cNvSpPr/>
          <p:nvPr/>
        </p:nvSpPr>
        <p:spPr>
          <a:xfrm>
            <a:off x="1523880" y="3809880"/>
            <a:ext cx="42840" cy="47880"/>
          </a:xfrm>
          <a:custGeom>
            <a:avLst/>
            <a:gdLst/>
            <a:ahLst/>
            <a:rect l="l" t="t" r="r" b="b"/>
            <a:pathLst>
              <a:path w="42863" h="47625">
                <a:moveTo>
                  <a:pt x="0" y="18191"/>
                </a:moveTo>
                <a:lnTo>
                  <a:pt x="16372" y="18191"/>
                </a:lnTo>
                <a:lnTo>
                  <a:pt x="21432" y="0"/>
                </a:lnTo>
                <a:lnTo>
                  <a:pt x="26491" y="18191"/>
                </a:lnTo>
                <a:lnTo>
                  <a:pt x="-22673" y="18191"/>
                </a:lnTo>
                <a:lnTo>
                  <a:pt x="29617" y="29434"/>
                </a:lnTo>
                <a:lnTo>
                  <a:pt x="-30859" y="-17911"/>
                </a:lnTo>
                <a:lnTo>
                  <a:pt x="21432" y="-29154"/>
                </a:lnTo>
                <a:lnTo>
                  <a:pt x="8186" y="-17911"/>
                </a:lnTo>
                <a:lnTo>
                  <a:pt x="13246" y="29434"/>
                </a:lnTo>
                <a:lnTo>
                  <a:pt x="0" y="18191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AutoShape 26"/>
          <p:cNvSpPr/>
          <p:nvPr/>
        </p:nvSpPr>
        <p:spPr>
          <a:xfrm>
            <a:off x="4876920" y="3200400"/>
            <a:ext cx="46080" cy="46080"/>
          </a:xfrm>
          <a:prstGeom prst="diamond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3760" bIns="-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lowchart: Connector 22"/>
          <p:cNvSpPr/>
          <p:nvPr/>
        </p:nvSpPr>
        <p:spPr>
          <a:xfrm>
            <a:off x="6629400" y="3738600"/>
            <a:ext cx="5724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AutoShape 26"/>
          <p:cNvSpPr/>
          <p:nvPr/>
        </p:nvSpPr>
        <p:spPr>
          <a:xfrm>
            <a:off x="4782960" y="4111560"/>
            <a:ext cx="46080" cy="46080"/>
          </a:xfrm>
          <a:prstGeom prst="diamond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3760" bIns="-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lowchart: Connector 24"/>
          <p:cNvSpPr/>
          <p:nvPr/>
        </p:nvSpPr>
        <p:spPr>
          <a:xfrm>
            <a:off x="2771640" y="5894280"/>
            <a:ext cx="5724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AutoShape 42"/>
          <p:cNvSpPr/>
          <p:nvPr/>
        </p:nvSpPr>
        <p:spPr>
          <a:xfrm>
            <a:off x="2354400" y="6477120"/>
            <a:ext cx="42840" cy="47520"/>
          </a:xfrm>
          <a:custGeom>
            <a:avLst/>
            <a:gdLst/>
            <a:ahLst/>
            <a:rect l="l" t="t" r="r" b="b"/>
            <a:pathLst>
              <a:path w="42862" h="47625">
                <a:moveTo>
                  <a:pt x="0" y="18191"/>
                </a:moveTo>
                <a:lnTo>
                  <a:pt x="16372" y="18191"/>
                </a:lnTo>
                <a:lnTo>
                  <a:pt x="21431" y="0"/>
                </a:lnTo>
                <a:lnTo>
                  <a:pt x="26490" y="18191"/>
                </a:lnTo>
                <a:lnTo>
                  <a:pt x="-22674" y="18191"/>
                </a:lnTo>
                <a:lnTo>
                  <a:pt x="29617" y="29434"/>
                </a:lnTo>
                <a:lnTo>
                  <a:pt x="-30860" y="-17911"/>
                </a:lnTo>
                <a:lnTo>
                  <a:pt x="21431" y="-29154"/>
                </a:lnTo>
                <a:lnTo>
                  <a:pt x="8186" y="-17911"/>
                </a:lnTo>
                <a:lnTo>
                  <a:pt x="13245" y="29434"/>
                </a:lnTo>
                <a:lnTo>
                  <a:pt x="0" y="18191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20" descr="D:\SDF-1 manuscript\histo\H2w-2 10x-1.tif"/>
          <p:cNvPicPr/>
          <p:nvPr/>
        </p:nvPicPr>
        <p:blipFill>
          <a:blip r:embed="rId6"/>
          <a:stretch/>
        </p:blipFill>
        <p:spPr>
          <a:xfrm>
            <a:off x="1060560" y="7010280"/>
            <a:ext cx="2828880" cy="2121120"/>
          </a:xfrm>
          <a:prstGeom prst="rect">
            <a:avLst/>
          </a:prstGeom>
          <a:ln w="0">
            <a:noFill/>
          </a:ln>
        </p:spPr>
      </p:pic>
      <p:sp>
        <p:nvSpPr>
          <p:cNvPr id="90" name="Flowchart: Connector 26"/>
          <p:cNvSpPr/>
          <p:nvPr/>
        </p:nvSpPr>
        <p:spPr>
          <a:xfrm>
            <a:off x="1905120" y="7696080"/>
            <a:ext cx="5688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AutoShape 42"/>
          <p:cNvSpPr/>
          <p:nvPr/>
        </p:nvSpPr>
        <p:spPr>
          <a:xfrm>
            <a:off x="2508120" y="7873920"/>
            <a:ext cx="42840" cy="47880"/>
          </a:xfrm>
          <a:custGeom>
            <a:avLst/>
            <a:gdLst/>
            <a:ahLst/>
            <a:rect l="l" t="t" r="r" b="b"/>
            <a:pathLst>
              <a:path w="42863" h="47625">
                <a:moveTo>
                  <a:pt x="0" y="18191"/>
                </a:moveTo>
                <a:lnTo>
                  <a:pt x="16372" y="18191"/>
                </a:lnTo>
                <a:lnTo>
                  <a:pt x="21432" y="0"/>
                </a:lnTo>
                <a:lnTo>
                  <a:pt x="26491" y="18191"/>
                </a:lnTo>
                <a:lnTo>
                  <a:pt x="-22673" y="18191"/>
                </a:lnTo>
                <a:lnTo>
                  <a:pt x="29617" y="29434"/>
                </a:lnTo>
                <a:lnTo>
                  <a:pt x="-30859" y="-17911"/>
                </a:lnTo>
                <a:lnTo>
                  <a:pt x="21432" y="-29154"/>
                </a:lnTo>
                <a:lnTo>
                  <a:pt x="8186" y="-17911"/>
                </a:lnTo>
                <a:lnTo>
                  <a:pt x="13246" y="29434"/>
                </a:lnTo>
                <a:lnTo>
                  <a:pt x="0" y="18191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080" bIns="1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Picture 21" descr="D:\SDF-1 manuscript\histo\G4w-1 10x-1.tif"/>
          <p:cNvPicPr/>
          <p:nvPr/>
        </p:nvPicPr>
        <p:blipFill>
          <a:blip r:embed="rId7"/>
          <a:stretch/>
        </p:blipFill>
        <p:spPr>
          <a:xfrm>
            <a:off x="3944880" y="4800600"/>
            <a:ext cx="2827440" cy="2120760"/>
          </a:xfrm>
          <a:prstGeom prst="rect">
            <a:avLst/>
          </a:prstGeom>
          <a:ln w="0">
            <a:noFill/>
          </a:ln>
        </p:spPr>
      </p:pic>
      <p:sp>
        <p:nvSpPr>
          <p:cNvPr id="93" name="Flowchart: Connector 29"/>
          <p:cNvSpPr/>
          <p:nvPr/>
        </p:nvSpPr>
        <p:spPr>
          <a:xfrm>
            <a:off x="4923000" y="5811840"/>
            <a:ext cx="5688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AutoShape 26"/>
          <p:cNvSpPr/>
          <p:nvPr/>
        </p:nvSpPr>
        <p:spPr>
          <a:xfrm>
            <a:off x="5257800" y="6116760"/>
            <a:ext cx="46080" cy="46080"/>
          </a:xfrm>
          <a:prstGeom prst="diamond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3760" bIns="-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22" descr="D:\SDF-1 manuscript\histo\H4w-1 10x-1.tif"/>
          <p:cNvPicPr/>
          <p:nvPr/>
        </p:nvPicPr>
        <p:blipFill>
          <a:blip r:embed="rId8"/>
          <a:stretch/>
        </p:blipFill>
        <p:spPr>
          <a:xfrm>
            <a:off x="3952800" y="7010280"/>
            <a:ext cx="2828880" cy="2121120"/>
          </a:xfrm>
          <a:prstGeom prst="rect">
            <a:avLst/>
          </a:prstGeom>
          <a:ln w="0">
            <a:noFill/>
          </a:ln>
        </p:spPr>
      </p:pic>
      <p:sp>
        <p:nvSpPr>
          <p:cNvPr id="96" name="Flowchart: Connector 32"/>
          <p:cNvSpPr/>
          <p:nvPr/>
        </p:nvSpPr>
        <p:spPr>
          <a:xfrm>
            <a:off x="4724280" y="7543800"/>
            <a:ext cx="57240" cy="49320"/>
          </a:xfrm>
          <a:prstGeom prst="flowChartConnector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AutoShape 26"/>
          <p:cNvSpPr/>
          <p:nvPr/>
        </p:nvSpPr>
        <p:spPr>
          <a:xfrm>
            <a:off x="4979880" y="7223040"/>
            <a:ext cx="46080" cy="46080"/>
          </a:xfrm>
          <a:prstGeom prst="diamond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3760" bIns="-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AutoShape 42"/>
          <p:cNvSpPr/>
          <p:nvPr/>
        </p:nvSpPr>
        <p:spPr>
          <a:xfrm>
            <a:off x="6292800" y="1571760"/>
            <a:ext cx="42840" cy="47520"/>
          </a:xfrm>
          <a:custGeom>
            <a:avLst/>
            <a:gdLst/>
            <a:ahLst/>
            <a:rect l="l" t="t" r="r" b="b"/>
            <a:pathLst>
              <a:path w="42863" h="47625">
                <a:moveTo>
                  <a:pt x="0" y="18191"/>
                </a:moveTo>
                <a:lnTo>
                  <a:pt x="16372" y="18191"/>
                </a:lnTo>
                <a:lnTo>
                  <a:pt x="21432" y="0"/>
                </a:lnTo>
                <a:lnTo>
                  <a:pt x="26491" y="18191"/>
                </a:lnTo>
                <a:lnTo>
                  <a:pt x="-22673" y="18191"/>
                </a:lnTo>
                <a:lnTo>
                  <a:pt x="29617" y="29434"/>
                </a:lnTo>
                <a:lnTo>
                  <a:pt x="-30859" y="-17911"/>
                </a:lnTo>
                <a:lnTo>
                  <a:pt x="21432" y="-29154"/>
                </a:lnTo>
                <a:lnTo>
                  <a:pt x="8186" y="-17911"/>
                </a:lnTo>
                <a:lnTo>
                  <a:pt x="13246" y="29434"/>
                </a:lnTo>
                <a:lnTo>
                  <a:pt x="0" y="18191"/>
                </a:lnTo>
                <a:close/>
              </a:path>
            </a:pathLst>
          </a:cu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30T13:51:22Z</dcterms:created>
  <dc:creator>Qiming Jin</dc:creator>
  <dc:description/>
  <dc:language>en-US</dc:language>
  <cp:lastModifiedBy>Qiming Jin</cp:lastModifiedBy>
  <cp:lastPrinted>2014-02-11T02:14:16Z</cp:lastPrinted>
  <dcterms:modified xsi:type="dcterms:W3CDTF">2014-02-11T02:30:32Z</dcterms:modified>
  <cp:revision>20</cp:revision>
  <dc:subject/>
  <dc:title>PowerPoint Presentation</dc:title>
</cp:coreProperties>
</file>